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8" d="100"/>
          <a:sy n="68" d="100"/>
        </p:scale>
        <p:origin x="59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experiments\OO2105\DATA\OO2105-Shedding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1"/>
                <c:pt idx="0">
                  <c:v>62794</c:v>
                </c:pt>
              </c:numLit>
            </c:plus>
            <c:minus>
              <c:numLit>
                <c:formatCode>General</c:formatCode>
                <c:ptCount val="1"/>
                <c:pt idx="0">
                  <c:v>62794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O$11:$O$14</c:f>
              <c:strCache>
                <c:ptCount val="4"/>
                <c:pt idx="0">
                  <c:v>C</c:v>
                </c:pt>
                <c:pt idx="1">
                  <c:v>C+PRO</c:v>
                </c:pt>
                <c:pt idx="2">
                  <c:v>C+PRO+XYL</c:v>
                </c:pt>
                <c:pt idx="3">
                  <c:v>C+XOS</c:v>
                </c:pt>
              </c:strCache>
            </c:strRef>
          </c:cat>
          <c:val>
            <c:numRef>
              <c:f>Sheet1!$P$11:$P$14</c:f>
              <c:numCache>
                <c:formatCode>General</c:formatCode>
                <c:ptCount val="4"/>
                <c:pt idx="0" formatCode="0">
                  <c:v>498942.8571428571</c:v>
                </c:pt>
                <c:pt idx="1">
                  <c:v>367504.76190476189</c:v>
                </c:pt>
                <c:pt idx="2">
                  <c:v>299457.14285714284</c:v>
                </c:pt>
                <c:pt idx="3">
                  <c:v>375314.285714285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94-441F-B9AE-63886F40F8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22596776"/>
        <c:axId val="822597104"/>
      </c:barChart>
      <c:catAx>
        <c:axId val="8225967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22597104"/>
        <c:crosses val="autoZero"/>
        <c:auto val="1"/>
        <c:lblAlgn val="ctr"/>
        <c:lblOffset val="100"/>
        <c:noMultiLvlLbl val="0"/>
      </c:catAx>
      <c:valAx>
        <c:axId val="82259710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225967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3AFF9C-80EB-750E-09CB-257CE108BD2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E5F49B3-AB30-78D5-24DE-76F0822EC6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0B049B-F40C-5102-B242-85A75DF929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A1D20A-80BA-1D2F-12B2-C9D6CFC1EC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5F6441-161F-453D-29CF-8D701EE13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6699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C3D4998-A882-92C8-921A-BE8FBA6224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E25EB93-14A6-EAAD-3406-2C5B8DBBCB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0EEEBD-98E0-5A5E-B143-1318D79AC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9E2B839-1C3F-1081-3A51-B0D09BC62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92FBDC-CF2B-6A96-A7C1-9AA82989E2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53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8898831-C07F-6BFA-10AE-A83FFEF520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B44F04B-5CA9-04E3-F448-EA0A40A3E6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F0BC3EA-1830-0AB4-B5B8-DCAB2F859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C81D4D-A4FF-72AE-13E1-68651ABC70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8A77BF-F97B-880A-7B4E-7F347EE44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36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610A1F8-34CD-8A39-1A1E-A6A00FF9FC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77D6727-48F5-A009-5B69-C07A937E3F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26CB898-666E-0B94-E4E7-E28BAF15B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492A7EE-5AA8-22C4-FC2F-287959EC27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B45107C-FD17-7EA0-0CE1-282B4D081D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74768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753D35-916B-580F-8B96-656BE0BDEF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DF5D3B7-3C65-A83A-ECC6-DBFEB91717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41EC3B-8176-BA17-D715-B47798875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CD8A88D-7748-06A0-D4B6-25538366D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717219-098D-5FBA-1578-7DB933B6AA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0442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423745-7C85-CB28-4BD7-B0F1778FB6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C8D213D-E478-9E6C-136F-51DCBC1721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6855465-5289-D820-1621-8DB2FCF9CE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503D9B-4DAB-C0F1-023E-E59F6074AC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D0FB8C-1507-6023-FB4C-548CCE0F8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65D0295-936A-994E-78F8-B6F265D0D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89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DA8B8A-AE6D-09A7-4AF4-FD8C9AF6CB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93DB9CE-9BAC-550B-C97E-07E80410C9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63CEA6E-67F3-2664-5DB7-A4DAE08469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2B2F695-8BD1-C1C9-CEB3-7FA5E38B97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27D525B-0C5F-25DC-32A5-1E491EB6239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60BABC6-E63E-2151-DF8C-09FF741E59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F20756-A573-2884-E963-6A881ADD6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CDBC0EA-FA47-6B7D-DFC6-78FEEF9860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5459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BB034C-4F41-CA91-086A-98C313F386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2BD5136-674B-31E4-1A18-D7DAB49054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29A7E92-1999-718A-24FF-12E5AA84E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9DF32816-26B4-95C0-ABBF-6527767719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07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B200E63-403F-8EC4-AFE2-B93C29A366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F320676-C9F4-271F-F578-7859122AD7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7825F47-1717-E8A7-EDE3-A231025DD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2856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6392BC-C7A8-941C-E74C-0F1AF10ACF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3E2A46C-A2BD-9D54-3184-6FE3E92119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270F022-24E6-4014-54E0-2A7FA0490B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DD0D8ED-98F7-446F-DB30-F8DEB12C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A0DED42-62A1-13ED-6B54-A0B653021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3CB3A81-0FA3-8119-5AD7-D1E2788B3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771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3690B3-CE0D-2CC6-907D-7BB044E241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5F9A77CD-0BC4-8650-6940-6FE53F044E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04F6823-90EA-A4E2-5CA9-0A8D730C6C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B6F78B9-53B8-6EBB-CBEC-720163EBA2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053795A-2B16-4122-7D5B-CC01B5826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5DD9918-DB25-19D1-6302-476D8CCBC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901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84CE4825-DE73-BB6C-11EC-265C4341B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/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D924C5-6405-F3B8-06CB-10D36A7668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/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DAB3B39-8791-FE8D-266D-A72B2B0ACD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632745-2FC8-4E74-A7F2-8CC8EC217AFF}" type="datetimeFigureOut">
              <a:rPr lang="en-US" smtClean="0"/>
              <a:t>5/9/2023</a:t>
            </a:fld>
            <a:endParaRPr 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511E1C-96D6-4133-9C51-7AB20997EB2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6848C7-4F34-8E88-65EB-8482DED586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4285FD-8A09-424D-8351-2239C2D5EA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09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DF3E7EE-BC2A-47D4-BD5A-6E0699B2369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1325588"/>
              </p:ext>
            </p:extLst>
          </p:nvPr>
        </p:nvGraphicFramePr>
        <p:xfrm>
          <a:off x="3090333" y="1320799"/>
          <a:ext cx="6485467" cy="4301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601613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501DECC-8B8C-ADBD-3423-F6564FECA0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BAD1B55-010B-9343-6B53-8383E623B4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altLang="zh-CN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upplementary </a:t>
            </a:r>
            <a:r>
              <a:rPr lang="en-US" sz="1800" b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3. Oocyst shedding (oocysts/g) of </a:t>
            </a:r>
            <a:r>
              <a:rPr lang="en-US" sz="1800" b="1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Eimeria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-challenged broiler chickens in response to dietary supplementations (6 DPI).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 Uni"/>
                <a:cs typeface="Arial" panose="020B0604020202020204" pitchFamily="34" charset="0"/>
              </a:rPr>
              <a:t>N = 7. C, challenged-no enzyme treatment; C+P, challenged and supplemented with protease treatment; C+PX, challenged and supplemented with xylanase and protease and xylanase treatment; C+XOS, challenged and supplemented with xylo-oligosaccharides treatment. The error bars represent the SEM values.</a:t>
            </a:r>
            <a:endParaRPr lang="en-US" sz="18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84052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9</Words>
  <Application>Microsoft Office PowerPoint</Application>
  <PresentationFormat>宽屏</PresentationFormat>
  <Paragraphs>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g Lin</dc:creator>
  <cp:lastModifiedBy>Yang Lin</cp:lastModifiedBy>
  <cp:revision>4</cp:revision>
  <dcterms:created xsi:type="dcterms:W3CDTF">2022-09-18T03:06:25Z</dcterms:created>
  <dcterms:modified xsi:type="dcterms:W3CDTF">2023-05-09T19:17:43Z</dcterms:modified>
</cp:coreProperties>
</file>